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7"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78F6214-2F47-7C45-5279-5C9A9E9E11A8}" v="19" dt="2024-01-21T19:45:27.38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5958"/>
  </p:normalViewPr>
  <p:slideViewPr>
    <p:cSldViewPr snapToGrid="0">
      <p:cViewPr varScale="1">
        <p:scale>
          <a:sx n="52" d="100"/>
          <a:sy n="52" d="100"/>
        </p:scale>
        <p:origin x="2506" y="5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undley, Heather Ann" userId="9923bbf4-35ca-4515-b4c1-83653bfb90e1" providerId="ADAL" clId="{38A731C9-CBD0-DE42-B182-46FD686B4D8C}"/>
    <pc:docChg chg="undo custSel modSld">
      <pc:chgData name="Hundley, Heather Ann" userId="9923bbf4-35ca-4515-b4c1-83653bfb90e1" providerId="ADAL" clId="{38A731C9-CBD0-DE42-B182-46FD686B4D8C}" dt="2023-08-19T21:26:25.093" v="554" actId="1076"/>
      <pc:docMkLst>
        <pc:docMk/>
      </pc:docMkLst>
      <pc:sldChg chg="addSp delSp modSp mod">
        <pc:chgData name="Hundley, Heather Ann" userId="9923bbf4-35ca-4515-b4c1-83653bfb90e1" providerId="ADAL" clId="{38A731C9-CBD0-DE42-B182-46FD686B4D8C}" dt="2023-08-19T21:26:25.093" v="554" actId="1076"/>
        <pc:sldMkLst>
          <pc:docMk/>
          <pc:sldMk cId="3761422318" sldId="257"/>
        </pc:sldMkLst>
        <pc:spChg chg="mod">
          <ac:chgData name="Hundley, Heather Ann" userId="9923bbf4-35ca-4515-b4c1-83653bfb90e1" providerId="ADAL" clId="{38A731C9-CBD0-DE42-B182-46FD686B4D8C}" dt="2023-08-19T21:26:21.329" v="553" actId="2711"/>
          <ac:spMkLst>
            <pc:docMk/>
            <pc:sldMk cId="3761422318" sldId="257"/>
            <ac:spMk id="5" creationId="{CCAC5C10-F526-E20D-C0D3-70C84863145F}"/>
          </ac:spMkLst>
        </pc:spChg>
        <pc:spChg chg="mod">
          <ac:chgData name="Hundley, Heather Ann" userId="9923bbf4-35ca-4515-b4c1-83653bfb90e1" providerId="ADAL" clId="{38A731C9-CBD0-DE42-B182-46FD686B4D8C}" dt="2023-08-19T19:26:34.465" v="552" actId="20577"/>
          <ac:spMkLst>
            <pc:docMk/>
            <pc:sldMk cId="3761422318" sldId="257"/>
            <ac:spMk id="6" creationId="{775FCE52-28EC-54E4-E990-C0E18D18538E}"/>
          </ac:spMkLst>
        </pc:spChg>
        <pc:spChg chg="add mod">
          <ac:chgData name="Hundley, Heather Ann" userId="9923bbf4-35ca-4515-b4c1-83653bfb90e1" providerId="ADAL" clId="{38A731C9-CBD0-DE42-B182-46FD686B4D8C}" dt="2023-08-19T21:26:25.093" v="554" actId="1076"/>
          <ac:spMkLst>
            <pc:docMk/>
            <pc:sldMk cId="3761422318" sldId="257"/>
            <ac:spMk id="7" creationId="{DDC194C3-05D8-AF27-83C6-B13A036C058A}"/>
          </ac:spMkLst>
        </pc:spChg>
        <pc:grpChg chg="mod">
          <ac:chgData name="Hundley, Heather Ann" userId="9923bbf4-35ca-4515-b4c1-83653bfb90e1" providerId="ADAL" clId="{38A731C9-CBD0-DE42-B182-46FD686B4D8C}" dt="2023-08-19T13:14:09.305" v="3" actId="14100"/>
          <ac:grpSpMkLst>
            <pc:docMk/>
            <pc:sldMk cId="3761422318" sldId="257"/>
            <ac:grpSpMk id="4" creationId="{5E39417D-E5C9-C8D0-9ECC-A4044DE2AFCF}"/>
          </ac:grpSpMkLst>
        </pc:grpChg>
        <pc:picChg chg="add del mod">
          <ac:chgData name="Hundley, Heather Ann" userId="9923bbf4-35ca-4515-b4c1-83653bfb90e1" providerId="ADAL" clId="{38A731C9-CBD0-DE42-B182-46FD686B4D8C}" dt="2023-08-19T19:22:54.871" v="131" actId="478"/>
          <ac:picMkLst>
            <pc:docMk/>
            <pc:sldMk cId="3761422318" sldId="257"/>
            <ac:picMk id="8" creationId="{4A7F063E-49F7-B9AF-A75C-A05D9B1EDEC5}"/>
          </ac:picMkLst>
        </pc:picChg>
        <pc:picChg chg="add del mod">
          <ac:chgData name="Hundley, Heather Ann" userId="9923bbf4-35ca-4515-b4c1-83653bfb90e1" providerId="ADAL" clId="{38A731C9-CBD0-DE42-B182-46FD686B4D8C}" dt="2023-08-19T13:19:06.062" v="122" actId="478"/>
          <ac:picMkLst>
            <pc:docMk/>
            <pc:sldMk cId="3761422318" sldId="257"/>
            <ac:picMk id="8" creationId="{D9714D77-DDDF-B88F-593C-7A8A249D180C}"/>
          </ac:picMkLst>
        </pc:picChg>
        <pc:picChg chg="add del mod">
          <ac:chgData name="Hundley, Heather Ann" userId="9923bbf4-35ca-4515-b4c1-83653bfb90e1" providerId="ADAL" clId="{38A731C9-CBD0-DE42-B182-46FD686B4D8C}" dt="2023-08-19T13:19:47.761" v="126" actId="478"/>
          <ac:picMkLst>
            <pc:docMk/>
            <pc:sldMk cId="3761422318" sldId="257"/>
            <ac:picMk id="9" creationId="{208273CA-6AAE-E0E2-EAFA-AC8A338FEEF4}"/>
          </ac:picMkLst>
        </pc:picChg>
        <pc:picChg chg="add mod">
          <ac:chgData name="Hundley, Heather Ann" userId="9923bbf4-35ca-4515-b4c1-83653bfb90e1" providerId="ADAL" clId="{38A731C9-CBD0-DE42-B182-46FD686B4D8C}" dt="2023-08-19T19:23:49.366" v="133" actId="1076"/>
          <ac:picMkLst>
            <pc:docMk/>
            <pc:sldMk cId="3761422318" sldId="257"/>
            <ac:picMk id="9" creationId="{842FA6F2-97C3-7075-EFE4-3C58EE18B3B6}"/>
          </ac:picMkLst>
        </pc:picChg>
        <pc:picChg chg="add del">
          <ac:chgData name="Hundley, Heather Ann" userId="9923bbf4-35ca-4515-b4c1-83653bfb90e1" providerId="ADAL" clId="{38A731C9-CBD0-DE42-B182-46FD686B4D8C}" dt="2023-08-19T16:32:09.556" v="128" actId="478"/>
          <ac:picMkLst>
            <pc:docMk/>
            <pc:sldMk cId="3761422318" sldId="257"/>
            <ac:picMk id="10" creationId="{8C08F6E4-EB10-B930-037F-E947A53F9383}"/>
          </ac:picMkLst>
        </pc:picChg>
      </pc:sldChg>
    </pc:docChg>
  </pc:docChgLst>
  <pc:docChgLst>
    <pc:chgData name="Salim, Chinnu" userId="S::chisalim@iu.edu::97f0121d-12bb-4de1-b0c3-9497d3c11a4c" providerId="AD" clId="Web-{90C200F0-98EF-0258-4223-EF82FE863B75}"/>
    <pc:docChg chg="modSld">
      <pc:chgData name="Salim, Chinnu" userId="S::chisalim@iu.edu::97f0121d-12bb-4de1-b0c3-9497d3c11a4c" providerId="AD" clId="Web-{90C200F0-98EF-0258-4223-EF82FE863B75}" dt="2023-08-18T20:25:04.312" v="2" actId="20577"/>
      <pc:docMkLst>
        <pc:docMk/>
      </pc:docMkLst>
      <pc:sldChg chg="modSp">
        <pc:chgData name="Salim, Chinnu" userId="S::chisalim@iu.edu::97f0121d-12bb-4de1-b0c3-9497d3c11a4c" providerId="AD" clId="Web-{90C200F0-98EF-0258-4223-EF82FE863B75}" dt="2023-08-18T20:25:04.312" v="2" actId="20577"/>
        <pc:sldMkLst>
          <pc:docMk/>
          <pc:sldMk cId="3761422318" sldId="257"/>
        </pc:sldMkLst>
        <pc:spChg chg="mod">
          <ac:chgData name="Salim, Chinnu" userId="S::chisalim@iu.edu::97f0121d-12bb-4de1-b0c3-9497d3c11a4c" providerId="AD" clId="Web-{90C200F0-98EF-0258-4223-EF82FE863B75}" dt="2023-08-18T20:25:04.312" v="2" actId="20577"/>
          <ac:spMkLst>
            <pc:docMk/>
            <pc:sldMk cId="3761422318" sldId="257"/>
            <ac:spMk id="6" creationId="{775FCE52-28EC-54E4-E990-C0E18D18538E}"/>
          </ac:spMkLst>
        </pc:spChg>
      </pc:sldChg>
    </pc:docChg>
  </pc:docChgLst>
  <pc:docChgLst>
    <pc:chgData name="Salim, Chinnu" userId="S::chisalim@iu.edu::97f0121d-12bb-4de1-b0c3-9497d3c11a4c" providerId="AD" clId="Web-{F78F6214-2F47-7C45-5279-5C9A9E9E11A8}"/>
    <pc:docChg chg="modSld">
      <pc:chgData name="Salim, Chinnu" userId="S::chisalim@iu.edu::97f0121d-12bb-4de1-b0c3-9497d3c11a4c" providerId="AD" clId="Web-{F78F6214-2F47-7C45-5279-5C9A9E9E11A8}" dt="2024-01-21T19:45:25.056" v="8" actId="20577"/>
      <pc:docMkLst>
        <pc:docMk/>
      </pc:docMkLst>
      <pc:sldChg chg="modSp">
        <pc:chgData name="Salim, Chinnu" userId="S::chisalim@iu.edu::97f0121d-12bb-4de1-b0c3-9497d3c11a4c" providerId="AD" clId="Web-{F78F6214-2F47-7C45-5279-5C9A9E9E11A8}" dt="2024-01-21T19:45:25.056" v="8" actId="20577"/>
        <pc:sldMkLst>
          <pc:docMk/>
          <pc:sldMk cId="3761422318" sldId="257"/>
        </pc:sldMkLst>
        <pc:spChg chg="mod">
          <ac:chgData name="Salim, Chinnu" userId="S::chisalim@iu.edu::97f0121d-12bb-4de1-b0c3-9497d3c11a4c" providerId="AD" clId="Web-{F78F6214-2F47-7C45-5279-5C9A9E9E11A8}" dt="2024-01-21T19:45:25.056" v="8" actId="20577"/>
          <ac:spMkLst>
            <pc:docMk/>
            <pc:sldMk cId="3761422318" sldId="257"/>
            <ac:spMk id="6" creationId="{775FCE52-28EC-54E4-E990-C0E18D18538E}"/>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72441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28671928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953561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2895406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7569145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758651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A366CC7-C4AF-8842-B710-F2E0BE1893D3}" type="datetimeFigureOut">
              <a:rPr lang="en-US" smtClean="0"/>
              <a:t>1/2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9478445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A366CC7-C4AF-8842-B710-F2E0BE1893D3}" type="datetimeFigureOut">
              <a:rPr lang="en-US" smtClean="0"/>
              <a:t>1/2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7543480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A366CC7-C4AF-8842-B710-F2E0BE1893D3}" type="datetimeFigureOut">
              <a:rPr lang="en-US" smtClean="0"/>
              <a:t>1/2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6390793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0841979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321417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4A366CC7-C4AF-8842-B710-F2E0BE1893D3}" type="datetimeFigureOut">
              <a:rPr lang="en-US" smtClean="0"/>
              <a:t>1/21/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42B1DCCB-FEDC-054B-8CF0-7F3DF9291314}" type="slidenum">
              <a:rPr lang="en-US" smtClean="0"/>
              <a:t>‹#›</a:t>
            </a:fld>
            <a:endParaRPr lang="en-US"/>
          </a:p>
        </p:txBody>
      </p:sp>
    </p:spTree>
    <p:extLst>
      <p:ext uri="{BB962C8B-B14F-4D97-AF65-F5344CB8AC3E}">
        <p14:creationId xmlns:p14="http://schemas.microsoft.com/office/powerpoint/2010/main" val="24359984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5E39417D-E5C9-C8D0-9ECC-A4044DE2AFCF}"/>
              </a:ext>
            </a:extLst>
          </p:cNvPr>
          <p:cNvGrpSpPr/>
          <p:nvPr/>
        </p:nvGrpSpPr>
        <p:grpSpPr>
          <a:xfrm>
            <a:off x="974362" y="263426"/>
            <a:ext cx="3611493" cy="3671266"/>
            <a:chOff x="2241550" y="946150"/>
            <a:chExt cx="5422900" cy="4965700"/>
          </a:xfrm>
        </p:grpSpPr>
        <p:pic>
          <p:nvPicPr>
            <p:cNvPr id="2" name="Picture 1">
              <a:extLst>
                <a:ext uri="{FF2B5EF4-FFF2-40B4-BE49-F238E27FC236}">
                  <a16:creationId xmlns:a16="http://schemas.microsoft.com/office/drawing/2014/main" id="{7C871D59-59CA-D1D7-75EB-4FCE6061584C}"/>
                </a:ext>
              </a:extLst>
            </p:cNvPr>
            <p:cNvPicPr>
              <a:picLocks noChangeAspect="1"/>
            </p:cNvPicPr>
            <p:nvPr/>
          </p:nvPicPr>
          <p:blipFill>
            <a:blip r:embed="rId2"/>
            <a:stretch>
              <a:fillRect/>
            </a:stretch>
          </p:blipFill>
          <p:spPr>
            <a:xfrm>
              <a:off x="2241550" y="946150"/>
              <a:ext cx="5422900" cy="4965700"/>
            </a:xfrm>
            <a:prstGeom prst="rect">
              <a:avLst/>
            </a:prstGeom>
          </p:spPr>
        </p:pic>
        <p:sp>
          <p:nvSpPr>
            <p:cNvPr id="3" name="Rectangle 2">
              <a:extLst>
                <a:ext uri="{FF2B5EF4-FFF2-40B4-BE49-F238E27FC236}">
                  <a16:creationId xmlns:a16="http://schemas.microsoft.com/office/drawing/2014/main" id="{11D8A5A5-FC67-8E1D-81A0-1917B1F95A1F}"/>
                </a:ext>
              </a:extLst>
            </p:cNvPr>
            <p:cNvSpPr/>
            <p:nvPr/>
          </p:nvSpPr>
          <p:spPr>
            <a:xfrm>
              <a:off x="2241550" y="1000125"/>
              <a:ext cx="5328526" cy="4664951"/>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640"/>
            </a:p>
          </p:txBody>
        </p:sp>
      </p:grpSp>
      <p:sp>
        <p:nvSpPr>
          <p:cNvPr id="5" name="TextBox 4">
            <a:extLst>
              <a:ext uri="{FF2B5EF4-FFF2-40B4-BE49-F238E27FC236}">
                <a16:creationId xmlns:a16="http://schemas.microsoft.com/office/drawing/2014/main" id="{CCAC5C10-F526-E20D-C0D3-70C84863145F}"/>
              </a:ext>
            </a:extLst>
          </p:cNvPr>
          <p:cNvSpPr txBox="1"/>
          <p:nvPr/>
        </p:nvSpPr>
        <p:spPr>
          <a:xfrm>
            <a:off x="374754" y="7875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775FCE52-28EC-54E4-E990-C0E18D18538E}"/>
              </a:ext>
            </a:extLst>
          </p:cNvPr>
          <p:cNvSpPr txBox="1"/>
          <p:nvPr/>
        </p:nvSpPr>
        <p:spPr>
          <a:xfrm>
            <a:off x="85200" y="6673565"/>
            <a:ext cx="7687200" cy="1569660"/>
          </a:xfrm>
          <a:prstGeom prst="rect">
            <a:avLst/>
          </a:prstGeom>
          <a:noFill/>
        </p:spPr>
        <p:txBody>
          <a:bodyPr wrap="square" lIns="91440" tIns="45720" rIns="91440" bIns="45720" rtlCol="0" anchor="t">
            <a:spAutoFit/>
          </a:bodyPr>
          <a:lstStyle/>
          <a:p>
            <a:r>
              <a:rPr lang="en-US" sz="1200" b="1" dirty="0">
                <a:latin typeface="Arial"/>
                <a:cs typeface="Arial"/>
              </a:rPr>
              <a:t>Additional file 10: Fig. S10. Gene set enrichment analysis of 332 </a:t>
            </a:r>
            <a:r>
              <a:rPr lang="en-US" sz="1200" b="1" dirty="0" err="1">
                <a:latin typeface="Arial"/>
                <a:cs typeface="Arial"/>
              </a:rPr>
              <a:t>misregulated</a:t>
            </a:r>
            <a:r>
              <a:rPr lang="en-US" sz="1200" b="1" dirty="0">
                <a:latin typeface="Arial"/>
                <a:cs typeface="Arial"/>
              </a:rPr>
              <a:t> genes in </a:t>
            </a:r>
            <a:r>
              <a:rPr lang="en-US" sz="1200" b="1" i="1" dirty="0">
                <a:latin typeface="Arial"/>
                <a:cs typeface="Arial"/>
              </a:rPr>
              <a:t>adr-1(-) </a:t>
            </a:r>
            <a:r>
              <a:rPr lang="en-US" sz="1200" b="1" dirty="0">
                <a:latin typeface="Arial"/>
                <a:cs typeface="Arial"/>
              </a:rPr>
              <a:t>animals and ADR-1 dsRBD1 mutant animals exposed to PA14</a:t>
            </a:r>
            <a:r>
              <a:rPr lang="en-US" sz="1200" dirty="0">
                <a:latin typeface="Arial"/>
                <a:cs typeface="Arial"/>
              </a:rPr>
              <a:t>. A) </a:t>
            </a:r>
            <a:r>
              <a:rPr lang="en-US" sz="1200" dirty="0" err="1">
                <a:latin typeface="Arial"/>
                <a:cs typeface="Arial"/>
              </a:rPr>
              <a:t>WormCat</a:t>
            </a:r>
            <a:r>
              <a:rPr lang="en-US" sz="1200" dirty="0">
                <a:latin typeface="Arial"/>
                <a:cs typeface="Arial"/>
              </a:rPr>
              <a:t> output where P value is calculated using Fisher’s exact text. Count indicates the number of genes in each category. The size and color of the circles for each category signifies the number of genes (size) and the P value (color) for the given categories. B) </a:t>
            </a:r>
            <a:r>
              <a:rPr lang="en-US" sz="1200" dirty="0" err="1">
                <a:latin typeface="Arial"/>
                <a:cs typeface="Arial"/>
              </a:rPr>
              <a:t>FuncAssociate</a:t>
            </a:r>
            <a:r>
              <a:rPr lang="en-US" sz="1200" dirty="0">
                <a:latin typeface="Arial"/>
                <a:cs typeface="Arial"/>
              </a:rPr>
              <a:t> output. B) </a:t>
            </a:r>
            <a:r>
              <a:rPr lang="en-US" sz="1200" dirty="0" err="1">
                <a:latin typeface="Arial"/>
                <a:cs typeface="Arial"/>
              </a:rPr>
              <a:t>FuncAssociate</a:t>
            </a:r>
            <a:r>
              <a:rPr lang="en-US" sz="1200" dirty="0">
                <a:latin typeface="Arial"/>
                <a:cs typeface="Arial"/>
              </a:rPr>
              <a:t> output where N is the number of genes in the dataset that have the ontology, and X is the number of genes in the ontology/gene set. LOD is the logarithm (base 10) of the odd ratio. P is the p-value and </a:t>
            </a:r>
            <a:r>
              <a:rPr lang="en-US" sz="1200" dirty="0" err="1">
                <a:latin typeface="Arial"/>
                <a:cs typeface="Arial"/>
              </a:rPr>
              <a:t>P_adj</a:t>
            </a:r>
            <a:r>
              <a:rPr lang="en-US" sz="1200" dirty="0">
                <a:latin typeface="Arial"/>
                <a:cs typeface="Arial"/>
              </a:rPr>
              <a:t> is the resampling adjusted p-value. </a:t>
            </a:r>
            <a:r>
              <a:rPr lang="en-US" sz="1200" dirty="0" err="1">
                <a:latin typeface="Arial"/>
                <a:cs typeface="Arial"/>
              </a:rPr>
              <a:t>Attrib</a:t>
            </a:r>
            <a:r>
              <a:rPr lang="en-US" sz="1200" dirty="0">
                <a:latin typeface="Arial"/>
                <a:cs typeface="Arial"/>
              </a:rPr>
              <a:t> ID is the ontology group ID and </a:t>
            </a:r>
            <a:r>
              <a:rPr lang="en-US" sz="1200" dirty="0" err="1">
                <a:latin typeface="Arial"/>
                <a:cs typeface="Arial"/>
              </a:rPr>
              <a:t>attrib</a:t>
            </a:r>
            <a:r>
              <a:rPr lang="en-US" sz="1200" dirty="0">
                <a:latin typeface="Arial"/>
                <a:cs typeface="Arial"/>
              </a:rPr>
              <a:t> name is the ontology description.</a:t>
            </a:r>
          </a:p>
        </p:txBody>
      </p:sp>
      <p:sp>
        <p:nvSpPr>
          <p:cNvPr id="7" name="TextBox 6">
            <a:extLst>
              <a:ext uri="{FF2B5EF4-FFF2-40B4-BE49-F238E27FC236}">
                <a16:creationId xmlns:a16="http://schemas.microsoft.com/office/drawing/2014/main" id="{DDC194C3-05D8-AF27-83C6-B13A036C058A}"/>
              </a:ext>
            </a:extLst>
          </p:cNvPr>
          <p:cNvSpPr txBox="1"/>
          <p:nvPr/>
        </p:nvSpPr>
        <p:spPr>
          <a:xfrm>
            <a:off x="85200" y="3741034"/>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pic>
        <p:nvPicPr>
          <p:cNvPr id="9" name="Picture 8">
            <a:extLst>
              <a:ext uri="{FF2B5EF4-FFF2-40B4-BE49-F238E27FC236}">
                <a16:creationId xmlns:a16="http://schemas.microsoft.com/office/drawing/2014/main" id="{842FA6F2-97C3-7075-EFE4-3C58EE18B3B6}"/>
              </a:ext>
            </a:extLst>
          </p:cNvPr>
          <p:cNvPicPr>
            <a:picLocks noChangeAspect="1"/>
          </p:cNvPicPr>
          <p:nvPr/>
        </p:nvPicPr>
        <p:blipFill>
          <a:blip r:embed="rId3"/>
          <a:stretch>
            <a:fillRect/>
          </a:stretch>
        </p:blipFill>
        <p:spPr>
          <a:xfrm>
            <a:off x="158750" y="4110366"/>
            <a:ext cx="7454900" cy="2451100"/>
          </a:xfrm>
          <a:prstGeom prst="rect">
            <a:avLst/>
          </a:prstGeom>
        </p:spPr>
      </p:pic>
    </p:spTree>
    <p:extLst>
      <p:ext uri="{BB962C8B-B14F-4D97-AF65-F5344CB8AC3E}">
        <p14:creationId xmlns:p14="http://schemas.microsoft.com/office/powerpoint/2010/main" val="37614223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37</TotalTime>
  <Words>165</Words>
  <Application>Microsoft Office PowerPoint</Application>
  <PresentationFormat>Custom</PresentationFormat>
  <Paragraphs>3</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kal, Alfa</dc:creator>
  <cp:lastModifiedBy>Salim, Chinnu</cp:lastModifiedBy>
  <cp:revision>7</cp:revision>
  <dcterms:created xsi:type="dcterms:W3CDTF">2023-08-07T15:12:38Z</dcterms:created>
  <dcterms:modified xsi:type="dcterms:W3CDTF">2024-01-21T19:45:27Z</dcterms:modified>
</cp:coreProperties>
</file>